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24479250" cy="136794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B2CFDB-C652-498B-B2F4-3AB0B9AA91F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1682640" y="728640"/>
            <a:ext cx="21114000" cy="2643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endParaRPr b="0" lang="en-US" sz="8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1682640" y="3641760"/>
            <a:ext cx="21114000" cy="41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001"/>
              </a:spcBef>
              <a:buNone/>
              <a:tabLst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endParaRPr b="0" lang="en-US" sz="5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1682640" y="8175240"/>
            <a:ext cx="21114000" cy="41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001"/>
              </a:spcBef>
              <a:buNone/>
              <a:tabLst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endParaRPr b="0" lang="en-US" sz="5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39F711-F9A0-4B0F-8B12-773086D9D3C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1682640" y="728640"/>
            <a:ext cx="21114000" cy="2643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endParaRPr b="0" lang="en-US" sz="8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1682640" y="3641760"/>
            <a:ext cx="10303560" cy="41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001"/>
              </a:spcBef>
              <a:buNone/>
              <a:tabLst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endParaRPr b="0" lang="en-US" sz="5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12501720" y="3641760"/>
            <a:ext cx="10303560" cy="41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001"/>
              </a:spcBef>
              <a:buNone/>
              <a:tabLst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endParaRPr b="0" lang="en-US" sz="5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1682640" y="8175240"/>
            <a:ext cx="10303560" cy="41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001"/>
              </a:spcBef>
              <a:buNone/>
              <a:tabLst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endParaRPr b="0" lang="en-US" sz="5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12501720" y="8175240"/>
            <a:ext cx="10303560" cy="41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001"/>
              </a:spcBef>
              <a:buNone/>
              <a:tabLst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endParaRPr b="0" lang="en-US" sz="5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1CF930-FCCA-4A2C-AF66-6219B2A891D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1682640" y="728640"/>
            <a:ext cx="21114000" cy="2643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endParaRPr b="0" lang="en-US" sz="8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1682640" y="3641760"/>
            <a:ext cx="6798600" cy="41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001"/>
              </a:spcBef>
              <a:buNone/>
              <a:tabLst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endParaRPr b="0" lang="en-US" sz="5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8821440" y="3641760"/>
            <a:ext cx="6798600" cy="41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001"/>
              </a:spcBef>
              <a:buNone/>
              <a:tabLst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endParaRPr b="0" lang="en-US" sz="5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15960600" y="3641760"/>
            <a:ext cx="6798600" cy="41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001"/>
              </a:spcBef>
              <a:buNone/>
              <a:tabLst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endParaRPr b="0" lang="en-US" sz="5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1682640" y="8175240"/>
            <a:ext cx="6798600" cy="41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001"/>
              </a:spcBef>
              <a:buNone/>
              <a:tabLst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endParaRPr b="0" lang="en-US" sz="5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8821440" y="8175240"/>
            <a:ext cx="6798600" cy="41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001"/>
              </a:spcBef>
              <a:buNone/>
              <a:tabLst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endParaRPr b="0" lang="en-US" sz="5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15960600" y="8175240"/>
            <a:ext cx="6798600" cy="41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001"/>
              </a:spcBef>
              <a:buNone/>
              <a:tabLst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endParaRPr b="0" lang="en-US" sz="5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F0DE51-0E92-464A-A7C2-D328B1940E8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1682640" y="728640"/>
            <a:ext cx="21114000" cy="2643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endParaRPr b="0" lang="en-US" sz="8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1682640" y="3641760"/>
            <a:ext cx="21114000" cy="8678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2001"/>
              </a:spcBef>
              <a:buNone/>
              <a:tabLst>
                <a:tab algn="l" pos="0"/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endParaRPr b="0" lang="en-US" sz="5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64B594-723B-4D68-B3D0-44F254609B9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1682640" y="728640"/>
            <a:ext cx="21114000" cy="2643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endParaRPr b="0" lang="en-US" sz="8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1682640" y="3641760"/>
            <a:ext cx="21114000" cy="8678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001"/>
              </a:spcBef>
              <a:buNone/>
              <a:tabLst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endParaRPr b="0" lang="en-US" sz="5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848ADB-51FA-4ED0-8255-6261EBD2423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1682640" y="728640"/>
            <a:ext cx="21114000" cy="2643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endParaRPr b="0" lang="en-US" sz="8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1682640" y="3641760"/>
            <a:ext cx="10303560" cy="8678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001"/>
              </a:spcBef>
              <a:buNone/>
              <a:tabLst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endParaRPr b="0" lang="en-US" sz="5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12501720" y="3641760"/>
            <a:ext cx="10303560" cy="8678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001"/>
              </a:spcBef>
              <a:buNone/>
              <a:tabLst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endParaRPr b="0" lang="en-US" sz="5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A930B5-BF38-466F-83C8-0961E137067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1682640" y="728640"/>
            <a:ext cx="21114000" cy="2643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endParaRPr b="0" lang="en-US" sz="8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387CDA-A492-4EC7-8322-DA7295B9EC2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1682640" y="728640"/>
            <a:ext cx="21114000" cy="12253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2001"/>
              </a:spcBef>
              <a:tabLst>
                <a:tab algn="l" pos="0"/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endParaRPr b="0" lang="en-US" sz="5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F8EE95-E80A-4BE7-934F-E4091EA5CD9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1682640" y="728640"/>
            <a:ext cx="21114000" cy="2643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endParaRPr b="0" lang="en-US" sz="8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1682640" y="3641760"/>
            <a:ext cx="10303560" cy="41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001"/>
              </a:spcBef>
              <a:buNone/>
              <a:tabLst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endParaRPr b="0" lang="en-US" sz="5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12501720" y="3641760"/>
            <a:ext cx="10303560" cy="8678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001"/>
              </a:spcBef>
              <a:buNone/>
              <a:tabLst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endParaRPr b="0" lang="en-US" sz="5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1682640" y="8175240"/>
            <a:ext cx="10303560" cy="41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001"/>
              </a:spcBef>
              <a:buNone/>
              <a:tabLst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endParaRPr b="0" lang="en-US" sz="5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A08C63-57EE-44A9-BF56-049E0AB82D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1682640" y="728640"/>
            <a:ext cx="21114000" cy="2643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endParaRPr b="0" lang="en-US" sz="8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1682640" y="3641760"/>
            <a:ext cx="10303560" cy="8678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001"/>
              </a:spcBef>
              <a:buNone/>
              <a:tabLst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endParaRPr b="0" lang="en-US" sz="5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12501720" y="3641760"/>
            <a:ext cx="10303560" cy="41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001"/>
              </a:spcBef>
              <a:buNone/>
              <a:tabLst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endParaRPr b="0" lang="en-US" sz="5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12501720" y="8175240"/>
            <a:ext cx="10303560" cy="41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001"/>
              </a:spcBef>
              <a:buNone/>
              <a:tabLst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endParaRPr b="0" lang="en-US" sz="5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662C7E-ADA4-4085-9CE7-619ABA7890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1682640" y="728640"/>
            <a:ext cx="21114000" cy="2643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endParaRPr b="0" lang="en-US" sz="8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1682640" y="3641760"/>
            <a:ext cx="10303560" cy="41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001"/>
              </a:spcBef>
              <a:buNone/>
              <a:tabLst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endParaRPr b="0" lang="en-US" sz="5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12501720" y="3641760"/>
            <a:ext cx="10303560" cy="41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001"/>
              </a:spcBef>
              <a:buNone/>
              <a:tabLst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endParaRPr b="0" lang="en-US" sz="5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1682640" y="8175240"/>
            <a:ext cx="21114000" cy="413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001"/>
              </a:spcBef>
              <a:buNone/>
              <a:tabLst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endParaRPr b="0" lang="en-US" sz="5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1230AB-1DD7-48E8-852E-559AF38275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1682640" y="728640"/>
            <a:ext cx="21114000" cy="2643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r>
              <a:rPr b="0" lang="en-US" sz="87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8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1682640" y="3641760"/>
            <a:ext cx="21114000" cy="8678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455760" indent="-455760">
              <a:lnSpc>
                <a:spcPct val="90000"/>
              </a:lnSpc>
              <a:spcBef>
                <a:spcPts val="2001"/>
              </a:spcBef>
              <a:buClr>
                <a:srgbClr val="000000"/>
              </a:buClr>
              <a:buFont typeface="Arial"/>
              <a:buChar char="•"/>
              <a:tabLst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r>
              <a:rPr b="0" lang="en-US" sz="55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5500" spc="-1" strike="noStrike">
              <a:solidFill>
                <a:srgbClr val="000000"/>
              </a:solidFill>
              <a:latin typeface="Calibri"/>
            </a:endParaRPr>
          </a:p>
          <a:p>
            <a:pPr lvl="1" marL="1366920" indent="-455760">
              <a:lnSpc>
                <a:spcPct val="90000"/>
              </a:lnSpc>
              <a:spcBef>
                <a:spcPts val="2001"/>
              </a:spcBef>
              <a:buClr>
                <a:srgbClr val="000000"/>
              </a:buClr>
              <a:buFont typeface="Arial"/>
              <a:buChar char="•"/>
              <a:tabLst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r>
              <a:rPr b="0" lang="en-US" sz="55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5500" spc="-1" strike="noStrike">
              <a:solidFill>
                <a:srgbClr val="000000"/>
              </a:solidFill>
              <a:latin typeface="Calibri"/>
            </a:endParaRPr>
          </a:p>
          <a:p>
            <a:pPr lvl="2" marL="2279520" indent="-455400">
              <a:lnSpc>
                <a:spcPct val="90000"/>
              </a:lnSpc>
              <a:spcBef>
                <a:spcPts val="2001"/>
              </a:spcBef>
              <a:buClr>
                <a:srgbClr val="000000"/>
              </a:buClr>
              <a:buFont typeface="Arial"/>
              <a:buChar char="•"/>
              <a:tabLst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r>
              <a:rPr b="0" lang="en-US" sz="55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5500" spc="-1" strike="noStrike">
              <a:solidFill>
                <a:srgbClr val="000000"/>
              </a:solidFill>
              <a:latin typeface="Calibri"/>
            </a:endParaRPr>
          </a:p>
          <a:p>
            <a:pPr lvl="3" marL="3191040" indent="-455760">
              <a:lnSpc>
                <a:spcPct val="90000"/>
              </a:lnSpc>
              <a:spcBef>
                <a:spcPts val="2001"/>
              </a:spcBef>
              <a:buClr>
                <a:srgbClr val="000000"/>
              </a:buClr>
              <a:buFont typeface="Arial"/>
              <a:buChar char="•"/>
              <a:tabLst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r>
              <a:rPr b="0" lang="en-US" sz="55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5500" spc="-1" strike="noStrike">
              <a:solidFill>
                <a:srgbClr val="000000"/>
              </a:solidFill>
              <a:latin typeface="Calibri"/>
            </a:endParaRPr>
          </a:p>
          <a:p>
            <a:pPr lvl="4" marL="4103640" indent="-455400">
              <a:lnSpc>
                <a:spcPct val="90000"/>
              </a:lnSpc>
              <a:spcBef>
                <a:spcPts val="2001"/>
              </a:spcBef>
              <a:buClr>
                <a:srgbClr val="000000"/>
              </a:buClr>
              <a:buFont typeface="Arial"/>
              <a:buChar char="•"/>
              <a:tabLst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r>
              <a:rPr b="0" lang="en-US" sz="55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5500" spc="-1" strike="noStrike">
              <a:solidFill>
                <a:srgbClr val="000000"/>
              </a:solidFill>
              <a:latin typeface="Calibri"/>
            </a:endParaRPr>
          </a:p>
          <a:p>
            <a:pPr lvl="5" marL="4103640" indent="-455400">
              <a:lnSpc>
                <a:spcPct val="90000"/>
              </a:lnSpc>
              <a:spcBef>
                <a:spcPts val="2001"/>
              </a:spcBef>
              <a:buClr>
                <a:srgbClr val="000000"/>
              </a:buClr>
              <a:buFont typeface="Arial"/>
              <a:buChar char="•"/>
              <a:tabLst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r>
              <a:rPr b="0" lang="en-US" sz="55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5500" spc="-1" strike="noStrike">
              <a:solidFill>
                <a:srgbClr val="000000"/>
              </a:solidFill>
              <a:latin typeface="Calibri"/>
            </a:endParaRPr>
          </a:p>
          <a:p>
            <a:pPr lvl="6" marL="4103640" indent="-455400">
              <a:lnSpc>
                <a:spcPct val="90000"/>
              </a:lnSpc>
              <a:spcBef>
                <a:spcPts val="2001"/>
              </a:spcBef>
              <a:buClr>
                <a:srgbClr val="000000"/>
              </a:buClr>
              <a:buFont typeface="Arial"/>
              <a:buChar char="•"/>
              <a:tabLst>
                <a:tab algn="l" pos="1822320"/>
                <a:tab algn="l" pos="3645000"/>
                <a:tab algn="l" pos="5467320"/>
                <a:tab algn="l" pos="7289640"/>
                <a:tab algn="l" pos="9112320"/>
                <a:tab algn="l" pos="10934640"/>
              </a:tabLst>
            </a:pPr>
            <a:r>
              <a:rPr b="0" lang="en-US" sz="55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5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1682640" y="12679200"/>
            <a:ext cx="5508720" cy="72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2300" spc="-1" strike="noStrike">
                <a:solidFill>
                  <a:srgbClr val="898989"/>
                </a:solidFill>
                <a:latin typeface="Calibri"/>
                <a:ea typeface="等线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zh-CN" sz="2300" spc="-1" strike="noStrike">
                <a:solidFill>
                  <a:srgbClr val="898989"/>
                </a:solidFill>
                <a:latin typeface="Calibri"/>
                <a:ea typeface="等线"/>
              </a:rPr>
              <a:t>&lt;date/time&gt;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8109000" y="12679200"/>
            <a:ext cx="8261280" cy="72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17287920" y="12679200"/>
            <a:ext cx="5508720" cy="72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2300" spc="-1" strike="noStrike">
                <a:solidFill>
                  <a:srgbClr val="898989"/>
                </a:solidFill>
                <a:latin typeface="Calibri"/>
                <a:ea typeface="等线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46352CF-790F-47D5-95C0-9E2F73AE4AAA}" type="slidenum">
              <a:rPr b="0" lang="zh-CN" sz="2300" spc="-1" strike="noStrike">
                <a:solidFill>
                  <a:srgbClr val="898989"/>
                </a:solidFill>
                <a:latin typeface="Calibri"/>
                <a:ea typeface="等线"/>
              </a:rPr>
              <a:t>&lt;number&gt;</a:t>
            </a:fld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文本框 40"/>
          <p:cNvSpPr/>
          <p:nvPr/>
        </p:nvSpPr>
        <p:spPr>
          <a:xfrm>
            <a:off x="515880" y="766800"/>
            <a:ext cx="833400" cy="56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3100" spc="-1" strike="noStrike">
                <a:solidFill>
                  <a:srgbClr val="000000"/>
                </a:solidFill>
                <a:latin typeface="Calibri"/>
                <a:ea typeface="等线"/>
              </a:rPr>
              <a:t>A</a:t>
            </a: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文本框 41"/>
          <p:cNvSpPr/>
          <p:nvPr/>
        </p:nvSpPr>
        <p:spPr>
          <a:xfrm>
            <a:off x="12374640" y="809640"/>
            <a:ext cx="939600" cy="53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900" spc="-1" strike="noStrike">
                <a:solidFill>
                  <a:srgbClr val="000000"/>
                </a:solidFill>
                <a:latin typeface="Calibri"/>
                <a:ea typeface="等线"/>
              </a:rPr>
              <a:t>B</a:t>
            </a: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文本框 42"/>
          <p:cNvSpPr/>
          <p:nvPr/>
        </p:nvSpPr>
        <p:spPr>
          <a:xfrm>
            <a:off x="515880" y="6973920"/>
            <a:ext cx="673200" cy="53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900" spc="-1" strike="noStrike">
                <a:solidFill>
                  <a:srgbClr val="000000"/>
                </a:solidFill>
                <a:latin typeface="Calibri"/>
                <a:ea typeface="等线"/>
              </a:rPr>
              <a:t>C</a:t>
            </a: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文本框 43"/>
          <p:cNvSpPr/>
          <p:nvPr/>
        </p:nvSpPr>
        <p:spPr>
          <a:xfrm>
            <a:off x="12414240" y="6973920"/>
            <a:ext cx="615960" cy="53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900" spc="-1" strike="noStrike">
                <a:solidFill>
                  <a:srgbClr val="000000"/>
                </a:solidFill>
                <a:latin typeface="Calibri"/>
                <a:ea typeface="等线"/>
              </a:rPr>
              <a:t>D</a:t>
            </a: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文本框 38"/>
          <p:cNvSpPr/>
          <p:nvPr/>
        </p:nvSpPr>
        <p:spPr>
          <a:xfrm>
            <a:off x="291960" y="0"/>
            <a:ext cx="19335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Calibri"/>
                <a:ea typeface="等线"/>
              </a:rPr>
              <a:t>Figure S1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6" name="图片 2" descr=""/>
          <p:cNvPicPr/>
          <p:nvPr/>
        </p:nvPicPr>
        <p:blipFill>
          <a:blip r:embed="rId1"/>
          <a:stretch/>
        </p:blipFill>
        <p:spPr>
          <a:xfrm>
            <a:off x="13030200" y="6973920"/>
            <a:ext cx="10260000" cy="6357960"/>
          </a:xfrm>
          <a:prstGeom prst="rect">
            <a:avLst/>
          </a:prstGeom>
          <a:ln w="0">
            <a:noFill/>
          </a:ln>
        </p:spPr>
      </p:pic>
      <p:pic>
        <p:nvPicPr>
          <p:cNvPr id="47" name="图片 3" descr=""/>
          <p:cNvPicPr/>
          <p:nvPr/>
        </p:nvPicPr>
        <p:blipFill>
          <a:blip r:embed="rId2"/>
          <a:stretch/>
        </p:blipFill>
        <p:spPr>
          <a:xfrm>
            <a:off x="1284120" y="6973920"/>
            <a:ext cx="9755280" cy="6357960"/>
          </a:xfrm>
          <a:prstGeom prst="rect">
            <a:avLst/>
          </a:prstGeom>
          <a:ln w="0">
            <a:noFill/>
          </a:ln>
        </p:spPr>
      </p:pic>
      <p:pic>
        <p:nvPicPr>
          <p:cNvPr id="48" name="图片 4" descr=""/>
          <p:cNvPicPr/>
          <p:nvPr/>
        </p:nvPicPr>
        <p:blipFill>
          <a:blip r:embed="rId3"/>
          <a:stretch/>
        </p:blipFill>
        <p:spPr>
          <a:xfrm>
            <a:off x="12868200" y="809640"/>
            <a:ext cx="10422000" cy="6172200"/>
          </a:xfrm>
          <a:prstGeom prst="rect">
            <a:avLst/>
          </a:prstGeom>
          <a:ln w="0">
            <a:noFill/>
          </a:ln>
        </p:spPr>
      </p:pic>
      <p:pic>
        <p:nvPicPr>
          <p:cNvPr id="49" name="图片 5" descr=""/>
          <p:cNvPicPr/>
          <p:nvPr/>
        </p:nvPicPr>
        <p:blipFill>
          <a:blip r:embed="rId4"/>
          <a:stretch/>
        </p:blipFill>
        <p:spPr>
          <a:xfrm>
            <a:off x="1273320" y="876240"/>
            <a:ext cx="10028160" cy="6181920"/>
          </a:xfrm>
          <a:prstGeom prst="rect">
            <a:avLst/>
          </a:prstGeom>
          <a:ln w="0">
            <a:noFill/>
          </a:ln>
        </p:spPr>
      </p:pic>
      <p:grpSp>
        <p:nvGrpSpPr>
          <p:cNvPr id="50" name="组合 6"/>
          <p:cNvGrpSpPr/>
          <p:nvPr/>
        </p:nvGrpSpPr>
        <p:grpSpPr>
          <a:xfrm>
            <a:off x="3000240" y="946080"/>
            <a:ext cx="3667320" cy="1321200"/>
            <a:chOff x="3000240" y="946080"/>
            <a:chExt cx="3667320" cy="1321200"/>
          </a:xfrm>
        </p:grpSpPr>
        <p:sp>
          <p:nvSpPr>
            <p:cNvPr id="51" name="文本框 17"/>
            <p:cNvSpPr/>
            <p:nvPr/>
          </p:nvSpPr>
          <p:spPr>
            <a:xfrm>
              <a:off x="3576240" y="946080"/>
              <a:ext cx="30913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  <a:ea typeface="等线"/>
                </a:rPr>
                <a:t>Pre-MRD positive/Haplo-SCT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文本框 21"/>
            <p:cNvSpPr/>
            <p:nvPr/>
          </p:nvSpPr>
          <p:spPr>
            <a:xfrm>
              <a:off x="3572640" y="1283400"/>
              <a:ext cx="27709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  <a:ea typeface="等线"/>
                </a:rPr>
                <a:t>Pre-MRD positive/MSDT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直接连接符 22"/>
            <p:cNvSpPr/>
            <p:nvPr/>
          </p:nvSpPr>
          <p:spPr>
            <a:xfrm>
              <a:off x="3006360" y="1154520"/>
              <a:ext cx="489600" cy="0"/>
            </a:xfrm>
            <a:prstGeom prst="line">
              <a:avLst/>
            </a:prstGeom>
            <a:ln w="28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直接连接符 23"/>
            <p:cNvSpPr/>
            <p:nvPr/>
          </p:nvSpPr>
          <p:spPr>
            <a:xfrm>
              <a:off x="3006360" y="1470600"/>
              <a:ext cx="489600" cy="0"/>
            </a:xfrm>
            <a:prstGeom prst="line">
              <a:avLst/>
            </a:prstGeom>
            <a:ln w="28440">
              <a:solidFill>
                <a:srgbClr val="00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文本框 24"/>
            <p:cNvSpPr/>
            <p:nvPr/>
          </p:nvSpPr>
          <p:spPr>
            <a:xfrm>
              <a:off x="3576240" y="1586880"/>
              <a:ext cx="30913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  <a:ea typeface="等线"/>
                </a:rPr>
                <a:t>Pre-MRD negative/Haplo-SCT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文本框 25"/>
            <p:cNvSpPr/>
            <p:nvPr/>
          </p:nvSpPr>
          <p:spPr>
            <a:xfrm>
              <a:off x="3585240" y="1899000"/>
              <a:ext cx="27709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  <a:ea typeface="等线"/>
                </a:rPr>
                <a:t>Pre-MRD negative/MSDT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直接连接符 26"/>
            <p:cNvSpPr/>
            <p:nvPr/>
          </p:nvSpPr>
          <p:spPr>
            <a:xfrm>
              <a:off x="3000240" y="1770120"/>
              <a:ext cx="489600" cy="0"/>
            </a:xfrm>
            <a:prstGeom prst="line">
              <a:avLst/>
            </a:prstGeom>
            <a:ln w="2844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直接连接符 27"/>
            <p:cNvSpPr/>
            <p:nvPr/>
          </p:nvSpPr>
          <p:spPr>
            <a:xfrm>
              <a:off x="3000240" y="2086200"/>
              <a:ext cx="489600" cy="0"/>
            </a:xfrm>
            <a:prstGeom prst="line">
              <a:avLst/>
            </a:prstGeom>
            <a:ln w="28440">
              <a:solidFill>
                <a:srgbClr val="00b05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59" name="组合 28"/>
          <p:cNvGrpSpPr/>
          <p:nvPr/>
        </p:nvGrpSpPr>
        <p:grpSpPr>
          <a:xfrm>
            <a:off x="15150960" y="927000"/>
            <a:ext cx="3667320" cy="1322640"/>
            <a:chOff x="15150960" y="927000"/>
            <a:chExt cx="3667320" cy="1322640"/>
          </a:xfrm>
        </p:grpSpPr>
        <p:sp>
          <p:nvSpPr>
            <p:cNvPr id="60" name="文本框 29"/>
            <p:cNvSpPr/>
            <p:nvPr/>
          </p:nvSpPr>
          <p:spPr>
            <a:xfrm>
              <a:off x="15726960" y="927000"/>
              <a:ext cx="30913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  <a:ea typeface="等线"/>
                </a:rPr>
                <a:t>Pre-MRD positive/Haplo-SCT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文本框 30"/>
            <p:cNvSpPr/>
            <p:nvPr/>
          </p:nvSpPr>
          <p:spPr>
            <a:xfrm>
              <a:off x="15723360" y="1265040"/>
              <a:ext cx="27709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  <a:ea typeface="等线"/>
                </a:rPr>
                <a:t>Pre-MRD positive/MSDT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直接连接符 31"/>
            <p:cNvSpPr/>
            <p:nvPr/>
          </p:nvSpPr>
          <p:spPr>
            <a:xfrm>
              <a:off x="15157080" y="1135800"/>
              <a:ext cx="489600" cy="0"/>
            </a:xfrm>
            <a:prstGeom prst="line">
              <a:avLst/>
            </a:prstGeom>
            <a:ln w="28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直接连接符 32"/>
            <p:cNvSpPr/>
            <p:nvPr/>
          </p:nvSpPr>
          <p:spPr>
            <a:xfrm>
              <a:off x="15157080" y="1452240"/>
              <a:ext cx="489600" cy="0"/>
            </a:xfrm>
            <a:prstGeom prst="line">
              <a:avLst/>
            </a:prstGeom>
            <a:ln w="28440">
              <a:solidFill>
                <a:srgbClr val="00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文本框 33"/>
            <p:cNvSpPr/>
            <p:nvPr/>
          </p:nvSpPr>
          <p:spPr>
            <a:xfrm>
              <a:off x="15726960" y="1568520"/>
              <a:ext cx="30913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  <a:ea typeface="等线"/>
                </a:rPr>
                <a:t>Pre-MRD negative/Haplo-SCT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文本框 34"/>
            <p:cNvSpPr/>
            <p:nvPr/>
          </p:nvSpPr>
          <p:spPr>
            <a:xfrm>
              <a:off x="15735960" y="1881360"/>
              <a:ext cx="27709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  <a:ea typeface="等线"/>
                </a:rPr>
                <a:t>Pre-MRD negative/MSDT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直接连接符 35"/>
            <p:cNvSpPr/>
            <p:nvPr/>
          </p:nvSpPr>
          <p:spPr>
            <a:xfrm>
              <a:off x="15150960" y="1752120"/>
              <a:ext cx="489600" cy="0"/>
            </a:xfrm>
            <a:prstGeom prst="line">
              <a:avLst/>
            </a:prstGeom>
            <a:ln w="2844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直接连接符 36"/>
            <p:cNvSpPr/>
            <p:nvPr/>
          </p:nvSpPr>
          <p:spPr>
            <a:xfrm>
              <a:off x="15150960" y="2068560"/>
              <a:ext cx="489600" cy="0"/>
            </a:xfrm>
            <a:prstGeom prst="line">
              <a:avLst/>
            </a:prstGeom>
            <a:ln w="28440">
              <a:solidFill>
                <a:srgbClr val="00b05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8" name="组合 37"/>
          <p:cNvGrpSpPr/>
          <p:nvPr/>
        </p:nvGrpSpPr>
        <p:grpSpPr>
          <a:xfrm>
            <a:off x="3079800" y="10753560"/>
            <a:ext cx="3666960" cy="1322640"/>
            <a:chOff x="3079800" y="10753560"/>
            <a:chExt cx="3666960" cy="1322640"/>
          </a:xfrm>
        </p:grpSpPr>
        <p:sp>
          <p:nvSpPr>
            <p:cNvPr id="69" name="文本框 39"/>
            <p:cNvSpPr/>
            <p:nvPr/>
          </p:nvSpPr>
          <p:spPr>
            <a:xfrm>
              <a:off x="3655800" y="10753560"/>
              <a:ext cx="30909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  <a:ea typeface="等线"/>
                </a:rPr>
                <a:t>Pre-MRD positive/Haplo-SCT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文本框 45"/>
            <p:cNvSpPr/>
            <p:nvPr/>
          </p:nvSpPr>
          <p:spPr>
            <a:xfrm>
              <a:off x="3652200" y="11091600"/>
              <a:ext cx="27709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  <a:ea typeface="等线"/>
                </a:rPr>
                <a:t>Pre-MRD positive/MSDT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直接连接符 46"/>
            <p:cNvSpPr/>
            <p:nvPr/>
          </p:nvSpPr>
          <p:spPr>
            <a:xfrm>
              <a:off x="3085920" y="10962360"/>
              <a:ext cx="489600" cy="0"/>
            </a:xfrm>
            <a:prstGeom prst="line">
              <a:avLst/>
            </a:prstGeom>
            <a:ln w="28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直接连接符 47"/>
            <p:cNvSpPr/>
            <p:nvPr/>
          </p:nvSpPr>
          <p:spPr>
            <a:xfrm>
              <a:off x="3085920" y="11278800"/>
              <a:ext cx="489600" cy="0"/>
            </a:xfrm>
            <a:prstGeom prst="line">
              <a:avLst/>
            </a:prstGeom>
            <a:ln w="28440">
              <a:solidFill>
                <a:srgbClr val="00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文本框 48"/>
            <p:cNvSpPr/>
            <p:nvPr/>
          </p:nvSpPr>
          <p:spPr>
            <a:xfrm>
              <a:off x="3655800" y="11395080"/>
              <a:ext cx="30909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  <a:ea typeface="等线"/>
                </a:rPr>
                <a:t>Pre-MRD negative/Haplo-SCT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文本框 49"/>
            <p:cNvSpPr/>
            <p:nvPr/>
          </p:nvSpPr>
          <p:spPr>
            <a:xfrm>
              <a:off x="3664800" y="11707920"/>
              <a:ext cx="27709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  <a:ea typeface="等线"/>
                </a:rPr>
                <a:t>Pre-MRD negative/MSDT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直接连接符 50"/>
            <p:cNvSpPr/>
            <p:nvPr/>
          </p:nvSpPr>
          <p:spPr>
            <a:xfrm>
              <a:off x="3079800" y="11578680"/>
              <a:ext cx="489600" cy="0"/>
            </a:xfrm>
            <a:prstGeom prst="line">
              <a:avLst/>
            </a:prstGeom>
            <a:ln w="2844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直接连接符 51"/>
            <p:cNvSpPr/>
            <p:nvPr/>
          </p:nvSpPr>
          <p:spPr>
            <a:xfrm>
              <a:off x="3079800" y="11895120"/>
              <a:ext cx="489600" cy="0"/>
            </a:xfrm>
            <a:prstGeom prst="line">
              <a:avLst/>
            </a:prstGeom>
            <a:ln w="28440">
              <a:solidFill>
                <a:srgbClr val="00b05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7" name="组合 52"/>
          <p:cNvGrpSpPr/>
          <p:nvPr/>
        </p:nvGrpSpPr>
        <p:grpSpPr>
          <a:xfrm>
            <a:off x="15230520" y="10736280"/>
            <a:ext cx="3666960" cy="1322280"/>
            <a:chOff x="15230520" y="10736280"/>
            <a:chExt cx="3666960" cy="1322280"/>
          </a:xfrm>
        </p:grpSpPr>
        <p:sp>
          <p:nvSpPr>
            <p:cNvPr id="78" name="文本框 53"/>
            <p:cNvSpPr/>
            <p:nvPr/>
          </p:nvSpPr>
          <p:spPr>
            <a:xfrm>
              <a:off x="15806520" y="10736280"/>
              <a:ext cx="30909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  <a:ea typeface="等线"/>
                </a:rPr>
                <a:t>Pre-MRD positive/Haplo-SCT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文本框 54"/>
            <p:cNvSpPr/>
            <p:nvPr/>
          </p:nvSpPr>
          <p:spPr>
            <a:xfrm>
              <a:off x="15802920" y="11073960"/>
              <a:ext cx="27709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  <a:ea typeface="等线"/>
                </a:rPr>
                <a:t>Pre-MRD positive/MSDT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直接连接符 55"/>
            <p:cNvSpPr/>
            <p:nvPr/>
          </p:nvSpPr>
          <p:spPr>
            <a:xfrm>
              <a:off x="15236640" y="10945080"/>
              <a:ext cx="489600" cy="0"/>
            </a:xfrm>
            <a:prstGeom prst="line">
              <a:avLst/>
            </a:prstGeom>
            <a:ln w="28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直接连接符 56"/>
            <p:cNvSpPr/>
            <p:nvPr/>
          </p:nvSpPr>
          <p:spPr>
            <a:xfrm>
              <a:off x="15236640" y="11261520"/>
              <a:ext cx="489600" cy="0"/>
            </a:xfrm>
            <a:prstGeom prst="line">
              <a:avLst/>
            </a:prstGeom>
            <a:ln w="28440">
              <a:solidFill>
                <a:srgbClr val="00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文本框 57"/>
            <p:cNvSpPr/>
            <p:nvPr/>
          </p:nvSpPr>
          <p:spPr>
            <a:xfrm>
              <a:off x="15806520" y="11377800"/>
              <a:ext cx="30909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  <a:ea typeface="等线"/>
                </a:rPr>
                <a:t>Pre-MRD negative/Haplo-SCT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文本框 58"/>
            <p:cNvSpPr/>
            <p:nvPr/>
          </p:nvSpPr>
          <p:spPr>
            <a:xfrm>
              <a:off x="15815520" y="11690280"/>
              <a:ext cx="27709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  <a:ea typeface="等线"/>
                </a:rPr>
                <a:t>Pre-MRD negative/MSDT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直接连接符 59"/>
            <p:cNvSpPr/>
            <p:nvPr/>
          </p:nvSpPr>
          <p:spPr>
            <a:xfrm>
              <a:off x="15230520" y="11561400"/>
              <a:ext cx="489600" cy="0"/>
            </a:xfrm>
            <a:prstGeom prst="line">
              <a:avLst/>
            </a:prstGeom>
            <a:ln w="2844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直接连接符 60"/>
            <p:cNvSpPr/>
            <p:nvPr/>
          </p:nvSpPr>
          <p:spPr>
            <a:xfrm>
              <a:off x="15230520" y="11877840"/>
              <a:ext cx="489600" cy="0"/>
            </a:xfrm>
            <a:prstGeom prst="line">
              <a:avLst/>
            </a:prstGeom>
            <a:ln w="28440">
              <a:solidFill>
                <a:srgbClr val="00b05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86" name="右大括号 1"/>
          <p:cNvSpPr/>
          <p:nvPr/>
        </p:nvSpPr>
        <p:spPr>
          <a:xfrm>
            <a:off x="8458200" y="3460680"/>
            <a:ext cx="203040" cy="1460520"/>
          </a:xfrm>
          <a:custGeom>
            <a:avLst/>
            <a:gdLst>
              <a:gd name="textAreaLeft" fmla="*/ 0 w 203040"/>
              <a:gd name="textAreaRight" fmla="*/ 73440 w 203040"/>
              <a:gd name="textAreaTop" fmla="*/ 5040 h 1460520"/>
              <a:gd name="textAreaBottom" fmla="*/ 1455480 h 14605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125"/>
                  <a:pt x="10800" y="250"/>
                </a:cubicBezTo>
                <a:lnTo>
                  <a:pt x="10800" y="10550"/>
                </a:lnTo>
                <a:cubicBezTo>
                  <a:pt x="10800" y="10675"/>
                  <a:pt x="16200" y="10800"/>
                  <a:pt x="21600" y="10800"/>
                </a:cubicBezTo>
                <a:cubicBezTo>
                  <a:pt x="16200" y="10800"/>
                  <a:pt x="10800" y="10925"/>
                  <a:pt x="10800" y="11050"/>
                </a:cubicBezTo>
                <a:lnTo>
                  <a:pt x="10800" y="21350"/>
                </a:lnTo>
                <a:cubicBezTo>
                  <a:pt x="10800" y="21475"/>
                  <a:pt x="5400" y="21600"/>
                  <a:pt x="0" y="21600"/>
                </a:cubicBezTo>
              </a:path>
            </a:pathLst>
          </a:cu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文本框 7"/>
          <p:cNvSpPr/>
          <p:nvPr/>
        </p:nvSpPr>
        <p:spPr>
          <a:xfrm>
            <a:off x="8745480" y="4002120"/>
            <a:ext cx="1098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Calibri"/>
                <a:ea typeface="等线"/>
              </a:rPr>
              <a:t>P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等线"/>
              </a:rPr>
              <a:t>&lt; 0.00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右大括号 8"/>
          <p:cNvSpPr/>
          <p:nvPr/>
        </p:nvSpPr>
        <p:spPr>
          <a:xfrm>
            <a:off x="10120320" y="4565520"/>
            <a:ext cx="262080" cy="457200"/>
          </a:xfrm>
          <a:custGeom>
            <a:avLst/>
            <a:gdLst>
              <a:gd name="textAreaLeft" fmla="*/ 0 w 262080"/>
              <a:gd name="textAreaRight" fmla="*/ 94680 w 262080"/>
              <a:gd name="textAreaTop" fmla="*/ 6480 h 457200"/>
              <a:gd name="textAreaBottom" fmla="*/ 450720 h 4572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515"/>
                  <a:pt x="10800" y="1029"/>
                </a:cubicBezTo>
                <a:lnTo>
                  <a:pt x="10800" y="9771"/>
                </a:lnTo>
                <a:cubicBezTo>
                  <a:pt x="10800" y="10286"/>
                  <a:pt x="16200" y="10800"/>
                  <a:pt x="21600" y="10800"/>
                </a:cubicBezTo>
                <a:cubicBezTo>
                  <a:pt x="16200" y="10800"/>
                  <a:pt x="10800" y="11315"/>
                  <a:pt x="10800" y="11829"/>
                </a:cubicBezTo>
                <a:lnTo>
                  <a:pt x="10800" y="20571"/>
                </a:lnTo>
                <a:cubicBezTo>
                  <a:pt x="10800" y="21086"/>
                  <a:pt x="5400" y="21600"/>
                  <a:pt x="0" y="21600"/>
                </a:cubicBezTo>
              </a:path>
            </a:pathLst>
          </a:cu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文本框 61"/>
          <p:cNvSpPr/>
          <p:nvPr/>
        </p:nvSpPr>
        <p:spPr>
          <a:xfrm>
            <a:off x="10665000" y="3817800"/>
            <a:ext cx="1098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Calibri"/>
                <a:ea typeface="等线"/>
              </a:rPr>
              <a:t>P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等线"/>
              </a:rPr>
              <a:t>&lt; 0.00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文本框 62"/>
          <p:cNvSpPr/>
          <p:nvPr/>
        </p:nvSpPr>
        <p:spPr>
          <a:xfrm>
            <a:off x="10396440" y="4594320"/>
            <a:ext cx="1098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Calibri"/>
                <a:ea typeface="等线"/>
              </a:rPr>
              <a:t>P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等线"/>
              </a:rPr>
              <a:t>=0.02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右大括号 9"/>
          <p:cNvSpPr/>
          <p:nvPr/>
        </p:nvSpPr>
        <p:spPr>
          <a:xfrm>
            <a:off x="10256760" y="3460680"/>
            <a:ext cx="216000" cy="1562040"/>
          </a:xfrm>
          <a:custGeom>
            <a:avLst/>
            <a:gdLst>
              <a:gd name="textAreaLeft" fmla="*/ 0 w 216000"/>
              <a:gd name="textAreaRight" fmla="*/ 78120 w 216000"/>
              <a:gd name="textAreaTop" fmla="*/ 5400 h 1562040"/>
              <a:gd name="textAreaBottom" fmla="*/ 1556640 h 1562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125"/>
                  <a:pt x="10800" y="249"/>
                </a:cubicBezTo>
                <a:lnTo>
                  <a:pt x="10800" y="10551"/>
                </a:lnTo>
                <a:cubicBezTo>
                  <a:pt x="10800" y="10676"/>
                  <a:pt x="16200" y="10800"/>
                  <a:pt x="21600" y="10800"/>
                </a:cubicBezTo>
                <a:cubicBezTo>
                  <a:pt x="16200" y="10800"/>
                  <a:pt x="10800" y="10925"/>
                  <a:pt x="10800" y="11049"/>
                </a:cubicBezTo>
                <a:lnTo>
                  <a:pt x="10800" y="21351"/>
                </a:lnTo>
                <a:cubicBezTo>
                  <a:pt x="10800" y="21476"/>
                  <a:pt x="5400" y="21600"/>
                  <a:pt x="0" y="21600"/>
                </a:cubicBezTo>
              </a:path>
            </a:pathLst>
          </a:cu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右大括号 10"/>
          <p:cNvSpPr/>
          <p:nvPr/>
        </p:nvSpPr>
        <p:spPr>
          <a:xfrm>
            <a:off x="8318520" y="8667720"/>
            <a:ext cx="190440" cy="1308240"/>
          </a:xfrm>
          <a:custGeom>
            <a:avLst/>
            <a:gdLst>
              <a:gd name="textAreaLeft" fmla="*/ 0 w 190440"/>
              <a:gd name="textAreaRight" fmla="*/ 68760 w 190440"/>
              <a:gd name="textAreaTop" fmla="*/ 4680 h 1308240"/>
              <a:gd name="textAreaBottom" fmla="*/ 1303560 h 13082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131"/>
                  <a:pt x="10800" y="262"/>
                </a:cubicBezTo>
                <a:lnTo>
                  <a:pt x="10800" y="10538"/>
                </a:lnTo>
                <a:cubicBezTo>
                  <a:pt x="10800" y="10669"/>
                  <a:pt x="16200" y="10800"/>
                  <a:pt x="21600" y="10800"/>
                </a:cubicBezTo>
                <a:cubicBezTo>
                  <a:pt x="16200" y="10800"/>
                  <a:pt x="10800" y="10931"/>
                  <a:pt x="10800" y="11062"/>
                </a:cubicBezTo>
                <a:lnTo>
                  <a:pt x="10800" y="21338"/>
                </a:lnTo>
                <a:cubicBezTo>
                  <a:pt x="10800" y="21469"/>
                  <a:pt x="5400" y="21600"/>
                  <a:pt x="0" y="21600"/>
                </a:cubicBezTo>
              </a:path>
            </a:pathLst>
          </a:cu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文本框 63"/>
          <p:cNvSpPr/>
          <p:nvPr/>
        </p:nvSpPr>
        <p:spPr>
          <a:xfrm>
            <a:off x="8604360" y="9137520"/>
            <a:ext cx="1098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Calibri"/>
                <a:ea typeface="等线"/>
              </a:rPr>
              <a:t>P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等线"/>
              </a:rPr>
              <a:t>=0.00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右大括号 11"/>
          <p:cNvSpPr/>
          <p:nvPr/>
        </p:nvSpPr>
        <p:spPr>
          <a:xfrm>
            <a:off x="9844200" y="8763120"/>
            <a:ext cx="276120" cy="1212840"/>
          </a:xfrm>
          <a:custGeom>
            <a:avLst/>
            <a:gdLst>
              <a:gd name="textAreaLeft" fmla="*/ 0 w 276120"/>
              <a:gd name="textAreaRight" fmla="*/ 99720 w 276120"/>
              <a:gd name="textAreaTop" fmla="*/ 7200 h 1212840"/>
              <a:gd name="textAreaBottom" fmla="*/ 1205640 h 12128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206"/>
                  <a:pt x="10800" y="411"/>
                </a:cubicBezTo>
                <a:lnTo>
                  <a:pt x="10800" y="10389"/>
                </a:lnTo>
                <a:cubicBezTo>
                  <a:pt x="10800" y="10595"/>
                  <a:pt x="16200" y="10800"/>
                  <a:pt x="21600" y="10800"/>
                </a:cubicBezTo>
                <a:cubicBezTo>
                  <a:pt x="16200" y="10800"/>
                  <a:pt x="10800" y="11006"/>
                  <a:pt x="10800" y="11211"/>
                </a:cubicBezTo>
                <a:lnTo>
                  <a:pt x="10800" y="21189"/>
                </a:lnTo>
                <a:cubicBezTo>
                  <a:pt x="10800" y="21395"/>
                  <a:pt x="5400" y="21600"/>
                  <a:pt x="0" y="21600"/>
                </a:cubicBezTo>
              </a:path>
            </a:pathLst>
          </a:cu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文本框 64"/>
          <p:cNvSpPr/>
          <p:nvPr/>
        </p:nvSpPr>
        <p:spPr>
          <a:xfrm>
            <a:off x="10132920" y="9185400"/>
            <a:ext cx="1098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Calibri"/>
                <a:ea typeface="等线"/>
              </a:rPr>
              <a:t>P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等线"/>
              </a:rPr>
              <a:t>=0.00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文本框 66"/>
          <p:cNvSpPr/>
          <p:nvPr/>
        </p:nvSpPr>
        <p:spPr>
          <a:xfrm>
            <a:off x="22596480" y="9128160"/>
            <a:ext cx="1098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Calibri"/>
                <a:ea typeface="等线"/>
              </a:rPr>
              <a:t>P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等线"/>
              </a:rPr>
              <a:t>=0.015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右大括号 12"/>
          <p:cNvSpPr/>
          <p:nvPr/>
        </p:nvSpPr>
        <p:spPr>
          <a:xfrm>
            <a:off x="22244040" y="8696160"/>
            <a:ext cx="235080" cy="1151280"/>
          </a:xfrm>
          <a:custGeom>
            <a:avLst/>
            <a:gdLst>
              <a:gd name="textAreaLeft" fmla="*/ 0 w 235080"/>
              <a:gd name="textAreaRight" fmla="*/ 84960 w 235080"/>
              <a:gd name="textAreaTop" fmla="*/ 6120 h 1151280"/>
              <a:gd name="textAreaBottom" fmla="*/ 1145160 h 11512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184"/>
                  <a:pt x="10800" y="367"/>
                </a:cubicBezTo>
                <a:lnTo>
                  <a:pt x="10800" y="10433"/>
                </a:lnTo>
                <a:cubicBezTo>
                  <a:pt x="10800" y="10617"/>
                  <a:pt x="16200" y="10800"/>
                  <a:pt x="21600" y="10800"/>
                </a:cubicBezTo>
                <a:cubicBezTo>
                  <a:pt x="16200" y="10800"/>
                  <a:pt x="10800" y="10984"/>
                  <a:pt x="10800" y="11167"/>
                </a:cubicBezTo>
                <a:lnTo>
                  <a:pt x="10800" y="21233"/>
                </a:lnTo>
                <a:cubicBezTo>
                  <a:pt x="10800" y="21417"/>
                  <a:pt x="5400" y="21600"/>
                  <a:pt x="0" y="21600"/>
                </a:cubicBezTo>
              </a:path>
            </a:pathLst>
          </a:cu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文本框 67"/>
          <p:cNvSpPr/>
          <p:nvPr/>
        </p:nvSpPr>
        <p:spPr>
          <a:xfrm>
            <a:off x="20554920" y="9013680"/>
            <a:ext cx="1098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Calibri"/>
                <a:ea typeface="等线"/>
              </a:rPr>
              <a:t>P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等线"/>
              </a:rPr>
              <a:t>=0.01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右大括号 13"/>
          <p:cNvSpPr/>
          <p:nvPr/>
        </p:nvSpPr>
        <p:spPr>
          <a:xfrm>
            <a:off x="20253240" y="8566200"/>
            <a:ext cx="301680" cy="1281240"/>
          </a:xfrm>
          <a:custGeom>
            <a:avLst/>
            <a:gdLst>
              <a:gd name="textAreaLeft" fmla="*/ 0 w 301680"/>
              <a:gd name="textAreaRight" fmla="*/ 108720 w 301680"/>
              <a:gd name="textAreaTop" fmla="*/ 7560 h 1281240"/>
              <a:gd name="textAreaBottom" fmla="*/ 1273680 h 12812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212"/>
                  <a:pt x="10800" y="423"/>
                </a:cubicBezTo>
                <a:lnTo>
                  <a:pt x="10800" y="10377"/>
                </a:lnTo>
                <a:cubicBezTo>
                  <a:pt x="10800" y="10589"/>
                  <a:pt x="16200" y="10800"/>
                  <a:pt x="21600" y="10800"/>
                </a:cubicBezTo>
                <a:cubicBezTo>
                  <a:pt x="16200" y="10800"/>
                  <a:pt x="10800" y="11012"/>
                  <a:pt x="10800" y="11223"/>
                </a:cubicBezTo>
                <a:lnTo>
                  <a:pt x="10800" y="21177"/>
                </a:lnTo>
                <a:cubicBezTo>
                  <a:pt x="10800" y="21389"/>
                  <a:pt x="5400" y="21600"/>
                  <a:pt x="0" y="21600"/>
                </a:cubicBezTo>
              </a:path>
            </a:pathLst>
          </a:cu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12-18T00:03:00Z</dcterms:created>
  <dc:creator>lenovo</dc:creator>
  <dc:description/>
  <dc:language>en-US</dc:language>
  <cp:lastModifiedBy> </cp:lastModifiedBy>
  <dcterms:modified xsi:type="dcterms:W3CDTF">2020-02-22T09:51:09Z</dcterms:modified>
  <cp:revision>19</cp:revision>
  <dc:subject/>
  <dc:title>PowerPoint 演示文稿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208</vt:lpwstr>
  </property>
</Properties>
</file>